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E320B-1451-499B-80CB-7BB8ECA5E8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66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03B79-6009-44DE-81A7-E7C07D845A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B3A27-E3B4-45AF-846E-C0B9CF8921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EF3DE-9612-43FC-8A26-6B346C09A5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D1D14-18B8-4834-9F7E-876570E585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77416-1BA9-496E-92CC-0653085052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CDC06-B4AD-43CE-995F-214B16B664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9F13A-D4A3-41F0-BA42-545F2C67AC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FD53A-28B0-4332-BC13-B3E4E662D8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4CD5F-D1C2-46FC-B590-08CA05794F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28191-66EA-4FB8-9162-78B5F30494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84B62-31FA-42D5-9F32-FD6E9E654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788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E23D86-A258-4774-ADA7-A95CEB08303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0880" y="8399520"/>
            <a:ext cx="6172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: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. Distributions of grain length in the four NIL populations grown in Zhejiang and Hainan, respectively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457200" y="382680"/>
            <a:ext cx="5821200" cy="8001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02T02:57:20Z</dcterms:created>
  <dc:creator>Administrator</dc:creator>
  <dc:description/>
  <dc:language>en-US</dc:language>
  <cp:lastModifiedBy>Reviewer</cp:lastModifiedBy>
  <dcterms:modified xsi:type="dcterms:W3CDTF">2016-06-03T01:38:42Z</dcterms:modified>
  <cp:revision>1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